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82296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52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1496484"/>
            <a:ext cx="6995160" cy="3183467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4802717"/>
            <a:ext cx="6172200" cy="2207683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005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494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486834"/>
            <a:ext cx="1774508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486834"/>
            <a:ext cx="5220653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807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023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2279653"/>
            <a:ext cx="7098030" cy="3803649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6119286"/>
            <a:ext cx="7098030" cy="2000249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>
                    <a:tint val="82000"/>
                  </a:schemeClr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82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778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2434167"/>
            <a:ext cx="349758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2434167"/>
            <a:ext cx="349758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343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486836"/>
            <a:ext cx="709803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2241551"/>
            <a:ext cx="3481506" cy="109854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3340100"/>
            <a:ext cx="3481506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2241551"/>
            <a:ext cx="3498652" cy="109854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3340100"/>
            <a:ext cx="349865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264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29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337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09600"/>
            <a:ext cx="2654260" cy="213360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1316569"/>
            <a:ext cx="4166235" cy="6498167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743200"/>
            <a:ext cx="2654260" cy="5082117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535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09600"/>
            <a:ext cx="2654260" cy="213360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1316569"/>
            <a:ext cx="4166235" cy="6498167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743200"/>
            <a:ext cx="2654260" cy="5082117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240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486836"/>
            <a:ext cx="709803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2434167"/>
            <a:ext cx="709803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8475136"/>
            <a:ext cx="185166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5DC171-A7DF-46B3-9043-C77D9E63B1F8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8475136"/>
            <a:ext cx="27774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8475136"/>
            <a:ext cx="185166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408545-C7AF-4C7E-84D3-474E0984A8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997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0EB8D72-CAB2-4FA2-1BA8-A07ED05D9B2D}"/>
              </a:ext>
            </a:extLst>
          </p:cNvPr>
          <p:cNvGrpSpPr/>
          <p:nvPr/>
        </p:nvGrpSpPr>
        <p:grpSpPr>
          <a:xfrm>
            <a:off x="1733417" y="2817767"/>
            <a:ext cx="4091043" cy="1311684"/>
            <a:chOff x="8030371" y="4464024"/>
            <a:chExt cx="4091043" cy="131168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500E4C40-E4F1-AA34-181B-5B4DF77A3EA2}"/>
                </a:ext>
              </a:extLst>
            </p:cNvPr>
            <p:cNvGrpSpPr/>
            <p:nvPr/>
          </p:nvGrpSpPr>
          <p:grpSpPr>
            <a:xfrm>
              <a:off x="8030371" y="4630052"/>
              <a:ext cx="4091043" cy="1145656"/>
              <a:chOff x="8030371" y="4630052"/>
              <a:chExt cx="4091043" cy="1145656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F8DD1C82-CF35-758E-646C-0011ECDDDAF2}"/>
                  </a:ext>
                </a:extLst>
              </p:cNvPr>
              <p:cNvGrpSpPr/>
              <p:nvPr/>
            </p:nvGrpSpPr>
            <p:grpSpPr>
              <a:xfrm>
                <a:off x="8030371" y="4630052"/>
                <a:ext cx="3429711" cy="1145656"/>
                <a:chOff x="8030371" y="4630052"/>
                <a:chExt cx="3429711" cy="1145656"/>
              </a:xfrm>
            </p:grpSpPr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A40D54C5-3D2A-B521-C062-FB93B2E268E7}"/>
                    </a:ext>
                  </a:extLst>
                </p:cNvPr>
                <p:cNvGrpSpPr/>
                <p:nvPr/>
              </p:nvGrpSpPr>
              <p:grpSpPr>
                <a:xfrm>
                  <a:off x="8030371" y="4630052"/>
                  <a:ext cx="3391804" cy="944632"/>
                  <a:chOff x="8030371" y="4630052"/>
                  <a:chExt cx="3391804" cy="944632"/>
                </a:xfrm>
              </p:grpSpPr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8B39A5AD-799C-756A-28DA-3EF0B3166469}"/>
                      </a:ext>
                    </a:extLst>
                  </p:cNvPr>
                  <p:cNvSpPr txBox="1"/>
                  <p:nvPr/>
                </p:nvSpPr>
                <p:spPr>
                  <a:xfrm>
                    <a:off x="8030371" y="5158792"/>
                    <a:ext cx="1534997" cy="14542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ts val="400"/>
                      </a:lnSpc>
                    </a:pPr>
                    <a:r>
                      <a: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gulation of supramolecular fiber organization</a:t>
                    </a:r>
                  </a:p>
                </p:txBody>
              </p:sp>
              <p:grpSp>
                <p:nvGrpSpPr>
                  <p:cNvPr id="23" name="Group 22">
                    <a:extLst>
                      <a:ext uri="{FF2B5EF4-FFF2-40B4-BE49-F238E27FC236}">
                        <a16:creationId xmlns:a16="http://schemas.microsoft.com/office/drawing/2014/main" id="{80255C98-4988-7B49-C869-E8092F8BF7F2}"/>
                      </a:ext>
                    </a:extLst>
                  </p:cNvPr>
                  <p:cNvGrpSpPr/>
                  <p:nvPr/>
                </p:nvGrpSpPr>
                <p:grpSpPr>
                  <a:xfrm>
                    <a:off x="8125835" y="4630052"/>
                    <a:ext cx="3296340" cy="944632"/>
                    <a:chOff x="8125835" y="4630052"/>
                    <a:chExt cx="3296340" cy="944632"/>
                  </a:xfrm>
                </p:grpSpPr>
                <p:sp>
                  <p:nvSpPr>
                    <p:cNvPr id="24" name="TextBox 23">
                      <a:extLst>
                        <a:ext uri="{FF2B5EF4-FFF2-40B4-BE49-F238E27FC236}">
                          <a16:creationId xmlns:a16="http://schemas.microsoft.com/office/drawing/2014/main" id="{8F32787F-EB77-A6C9-8896-D08CA1F5B49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88614" y="4980721"/>
                      <a:ext cx="1378346" cy="1454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>
                        <a:lnSpc>
                          <a:spcPts val="400"/>
                        </a:lnSpc>
                      </a:pPr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nucleoprotein complex biogenesis</a:t>
                      </a:r>
                    </a:p>
                  </p:txBody>
                </p:sp>
                <p:grpSp>
                  <p:nvGrpSpPr>
                    <p:cNvPr id="25" name="Group 24">
                      <a:extLst>
                        <a:ext uri="{FF2B5EF4-FFF2-40B4-BE49-F238E27FC236}">
                          <a16:creationId xmlns:a16="http://schemas.microsoft.com/office/drawing/2014/main" id="{D409FF2F-C422-C41A-DFB3-1A18C381F46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125835" y="4630052"/>
                      <a:ext cx="3296340" cy="944632"/>
                      <a:chOff x="8125835" y="4630052"/>
                      <a:chExt cx="3296340" cy="944632"/>
                    </a:xfrm>
                  </p:grpSpPr>
                  <p:pic>
                    <p:nvPicPr>
                      <p:cNvPr id="26" name="Picture 25">
                        <a:extLst>
                          <a:ext uri="{FF2B5EF4-FFF2-40B4-BE49-F238E27FC236}">
                            <a16:creationId xmlns:a16="http://schemas.microsoft.com/office/drawing/2014/main" id="{5AD3506A-480A-5C2E-14CB-077FAD67D562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2"/>
                      <a:srcRect l="26158" t="13306" r="20797" b="17642"/>
                      <a:stretch>
                        <a:fillRect/>
                      </a:stretch>
                    </p:blipFill>
                    <p:spPr>
                      <a:xfrm>
                        <a:off x="9511151" y="4644019"/>
                        <a:ext cx="1911024" cy="914401"/>
                      </a:xfrm>
                      <a:prstGeom prst="rect">
                        <a:avLst/>
                      </a:prstGeom>
                    </p:spPr>
                  </p:pic>
                  <p:grpSp>
                    <p:nvGrpSpPr>
                      <p:cNvPr id="27" name="Group 26">
                        <a:extLst>
                          <a:ext uri="{FF2B5EF4-FFF2-40B4-BE49-F238E27FC236}">
                            <a16:creationId xmlns:a16="http://schemas.microsoft.com/office/drawing/2014/main" id="{7E83CE6A-E971-00C5-BFD8-7F4215D5DB3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125835" y="4630052"/>
                        <a:ext cx="1503617" cy="398022"/>
                        <a:chOff x="8125835" y="4630052"/>
                        <a:chExt cx="1503617" cy="398022"/>
                      </a:xfrm>
                    </p:grpSpPr>
                    <p:grpSp>
                      <p:nvGrpSpPr>
                        <p:cNvPr id="32" name="Group 31">
                          <a:extLst>
                            <a:ext uri="{FF2B5EF4-FFF2-40B4-BE49-F238E27FC236}">
                              <a16:creationId xmlns:a16="http://schemas.microsoft.com/office/drawing/2014/main" id="{357149F8-B22A-76D6-4456-1E2903B5AD3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8125835" y="4630052"/>
                          <a:ext cx="1503617" cy="321885"/>
                          <a:chOff x="8125835" y="4630052"/>
                          <a:chExt cx="1503617" cy="321885"/>
                        </a:xfrm>
                      </p:grpSpPr>
                      <p:grpSp>
                        <p:nvGrpSpPr>
                          <p:cNvPr id="34" name="Group 33">
                            <a:extLst>
                              <a:ext uri="{FF2B5EF4-FFF2-40B4-BE49-F238E27FC236}">
                                <a16:creationId xmlns:a16="http://schemas.microsoft.com/office/drawing/2014/main" id="{E991DCF2-2F20-41AF-2664-332DAAE78DE1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8125835" y="4630052"/>
                            <a:ext cx="1503617" cy="239451"/>
                            <a:chOff x="8125835" y="4630052"/>
                            <a:chExt cx="1503617" cy="239451"/>
                          </a:xfrm>
                        </p:grpSpPr>
                        <p:sp>
                          <p:nvSpPr>
                            <p:cNvPr id="36" name="TextBox 35">
                              <a:extLst>
                                <a:ext uri="{FF2B5EF4-FFF2-40B4-BE49-F238E27FC236}">
                                  <a16:creationId xmlns:a16="http://schemas.microsoft.com/office/drawing/2014/main" id="{BA0AF9CE-016C-9F7A-771A-DBE5733E9B03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8125835" y="4630052"/>
                              <a:ext cx="1442450" cy="14542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r">
                                <a:lnSpc>
                                  <a:spcPts val="400"/>
                                </a:lnSpc>
                              </a:pPr>
                              <a:r>
                                <a:rPr lang="en-US" sz="5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Small GTPase-mediated signal transduction</a:t>
                              </a:r>
                            </a:p>
                          </p:txBody>
                        </p:sp>
                        <p:sp>
                          <p:nvSpPr>
                            <p:cNvPr id="37" name="TextBox 36">
                              <a:extLst>
                                <a:ext uri="{FF2B5EF4-FFF2-40B4-BE49-F238E27FC236}">
                                  <a16:creationId xmlns:a16="http://schemas.microsoft.com/office/drawing/2014/main" id="{05C7E531-C39F-5ABD-694B-D99EFD966C7D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8645684" y="4700226"/>
                              <a:ext cx="983768" cy="1692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5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Actin filament organization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35" name="TextBox 34">
                            <a:extLst>
                              <a:ext uri="{FF2B5EF4-FFF2-40B4-BE49-F238E27FC236}">
                                <a16:creationId xmlns:a16="http://schemas.microsoft.com/office/drawing/2014/main" id="{28F6232A-66F2-4B38-D5B1-46672E5B2A5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772320" y="4782660"/>
                            <a:ext cx="824241" cy="1692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5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Response to radiation</a:t>
                            </a:r>
                          </a:p>
                        </p:txBody>
                      </p:sp>
                    </p:grpSp>
                    <p:sp>
                      <p:nvSpPr>
                        <p:cNvPr id="33" name="TextBox 32">
                          <a:extLst>
                            <a:ext uri="{FF2B5EF4-FFF2-40B4-BE49-F238E27FC236}">
                              <a16:creationId xmlns:a16="http://schemas.microsoft.com/office/drawing/2014/main" id="{14E86F5C-C751-2CAD-270E-6B28E9CC09A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321774" y="4882650"/>
                          <a:ext cx="1245186" cy="14542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>
                            <a:lnSpc>
                              <a:spcPts val="400"/>
                            </a:lnSpc>
                          </a:pPr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Regulation of Wnt signaling pathway</a:t>
                          </a:r>
                        </a:p>
                      </p:txBody>
                    </p:sp>
                  </p:grpSp>
                  <p:sp>
                    <p:nvSpPr>
                      <p:cNvPr id="28" name="TextBox 27">
                        <a:extLst>
                          <a:ext uri="{FF2B5EF4-FFF2-40B4-BE49-F238E27FC236}">
                            <a16:creationId xmlns:a16="http://schemas.microsoft.com/office/drawing/2014/main" id="{DBF5E05C-D56E-B3AF-031E-9E528D8FD4D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397133" y="5068429"/>
                        <a:ext cx="1163732" cy="14542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>
                          <a:lnSpc>
                            <a:spcPts val="400"/>
                          </a:lnSpc>
                        </a:pPr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egulation of protein stability</a:t>
                        </a:r>
                      </a:p>
                    </p:txBody>
                  </p:sp>
                  <p:sp>
                    <p:nvSpPr>
                      <p:cNvPr id="29" name="TextBox 28">
                        <a:extLst>
                          <a:ext uri="{FF2B5EF4-FFF2-40B4-BE49-F238E27FC236}">
                            <a16:creationId xmlns:a16="http://schemas.microsoft.com/office/drawing/2014/main" id="{63D53958-5CA7-C26D-E2E1-2E53FF5545C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614863" y="5228799"/>
                        <a:ext cx="945623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Endosomal transport</a:t>
                        </a:r>
                      </a:p>
                    </p:txBody>
                  </p:sp>
                  <p:sp>
                    <p:nvSpPr>
                      <p:cNvPr id="30" name="TextBox 29">
                        <a:extLst>
                          <a:ext uri="{FF2B5EF4-FFF2-40B4-BE49-F238E27FC236}">
                            <a16:creationId xmlns:a16="http://schemas.microsoft.com/office/drawing/2014/main" id="{F559D7CB-3BBB-0751-3638-37BF031FA45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615608" y="5316769"/>
                        <a:ext cx="945623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Wnt signaling pathway</a:t>
                        </a:r>
                      </a:p>
                    </p:txBody>
                  </p:sp>
                  <p:sp>
                    <p:nvSpPr>
                      <p:cNvPr id="31" name="TextBox 30">
                        <a:extLst>
                          <a:ext uri="{FF2B5EF4-FFF2-40B4-BE49-F238E27FC236}">
                            <a16:creationId xmlns:a16="http://schemas.microsoft.com/office/drawing/2014/main" id="{3EFA7CE3-E524-F898-82EC-DEBF4D51D41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301678" y="5429260"/>
                        <a:ext cx="1265282" cy="14542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>
                          <a:lnSpc>
                            <a:spcPts val="400"/>
                          </a:lnSpc>
                        </a:pPr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embraneless organelle assembly</a:t>
                        </a:r>
                      </a:p>
                    </p:txBody>
                  </p:sp>
                </p:grpSp>
              </p:grpSp>
            </p:grp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BED02F1A-14F4-FB31-A4A4-EAF354053646}"/>
                    </a:ext>
                  </a:extLst>
                </p:cNvPr>
                <p:cNvSpPr txBox="1"/>
                <p:nvPr/>
              </p:nvSpPr>
              <p:spPr>
                <a:xfrm>
                  <a:off x="9513671" y="5525990"/>
                  <a:ext cx="21757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6B1E52EC-2357-CF3B-C3EA-A7F8EC73A365}"/>
                    </a:ext>
                  </a:extLst>
                </p:cNvPr>
                <p:cNvSpPr txBox="1"/>
                <p:nvPr/>
              </p:nvSpPr>
              <p:spPr>
                <a:xfrm>
                  <a:off x="9919278" y="5530110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DA872F46-881E-33E5-D956-E2E2C156433F}"/>
                    </a:ext>
                  </a:extLst>
                </p:cNvPr>
                <p:cNvSpPr txBox="1"/>
                <p:nvPr/>
              </p:nvSpPr>
              <p:spPr>
                <a:xfrm>
                  <a:off x="10333848" y="5530110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7EA69A4F-1647-8D16-7AE7-0C5C280E259E}"/>
                    </a:ext>
                  </a:extLst>
                </p:cNvPr>
                <p:cNvSpPr txBox="1"/>
                <p:nvPr/>
              </p:nvSpPr>
              <p:spPr>
                <a:xfrm>
                  <a:off x="10764787" y="5521792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1D8C28CD-681C-BD3A-81A2-BB31924BF48C}"/>
                    </a:ext>
                  </a:extLst>
                </p:cNvPr>
                <p:cNvSpPr txBox="1"/>
                <p:nvPr/>
              </p:nvSpPr>
              <p:spPr>
                <a:xfrm>
                  <a:off x="10123777" y="5606431"/>
                  <a:ext cx="754691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C5C8C35E-1192-3DC0-E19A-DBE2DDCD561D}"/>
                    </a:ext>
                  </a:extLst>
                </p:cNvPr>
                <p:cNvSpPr txBox="1"/>
                <p:nvPr/>
              </p:nvSpPr>
              <p:spPr>
                <a:xfrm>
                  <a:off x="11184266" y="5521791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A82CB703-179A-287E-7D8A-5C76B0F04BAD}"/>
                  </a:ext>
                </a:extLst>
              </p:cNvPr>
              <p:cNvGrpSpPr/>
              <p:nvPr/>
            </p:nvGrpSpPr>
            <p:grpSpPr>
              <a:xfrm>
                <a:off x="11366723" y="4633374"/>
                <a:ext cx="754691" cy="778212"/>
                <a:chOff x="11366723" y="4633374"/>
                <a:chExt cx="754691" cy="778212"/>
              </a:xfrm>
            </p:grpSpPr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097CC19F-927E-3BBC-79AB-AA92F68B1424}"/>
                    </a:ext>
                  </a:extLst>
                </p:cNvPr>
                <p:cNvGrpSpPr/>
                <p:nvPr/>
              </p:nvGrpSpPr>
              <p:grpSpPr>
                <a:xfrm>
                  <a:off x="11469012" y="4764602"/>
                  <a:ext cx="495303" cy="646984"/>
                  <a:chOff x="11469012" y="4764602"/>
                  <a:chExt cx="495303" cy="646984"/>
                </a:xfrm>
              </p:grpSpPr>
              <p:pic>
                <p:nvPicPr>
                  <p:cNvPr id="11" name="Picture 10">
                    <a:extLst>
                      <a:ext uri="{FF2B5EF4-FFF2-40B4-BE49-F238E27FC236}">
                        <a16:creationId xmlns:a16="http://schemas.microsoft.com/office/drawing/2014/main" id="{D714211D-6E89-0F52-0176-1D3CB15093D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rcRect l="81280" t="26777" r="14749" b="23004"/>
                  <a:stretch>
                    <a:fillRect/>
                  </a:stretch>
                </p:blipFill>
                <p:spPr>
                  <a:xfrm>
                    <a:off x="11469012" y="4799585"/>
                    <a:ext cx="116009" cy="612001"/>
                  </a:xfrm>
                  <a:prstGeom prst="rect">
                    <a:avLst/>
                  </a:prstGeom>
                </p:spPr>
              </p:pic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824637A8-996F-4212-8D3B-B84249920D78}"/>
                      </a:ext>
                    </a:extLst>
                  </p:cNvPr>
                  <p:cNvSpPr txBox="1"/>
                  <p:nvPr/>
                </p:nvSpPr>
                <p:spPr>
                  <a:xfrm>
                    <a:off x="11527016" y="4764602"/>
                    <a:ext cx="437299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e-09</a:t>
                    </a:r>
                  </a:p>
                </p:txBody>
              </p:sp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D8DC5BBB-4C4F-2F1B-14DA-B09B5758DCF4}"/>
                      </a:ext>
                    </a:extLst>
                  </p:cNvPr>
                  <p:cNvSpPr txBox="1"/>
                  <p:nvPr/>
                </p:nvSpPr>
                <p:spPr>
                  <a:xfrm>
                    <a:off x="11527015" y="4945925"/>
                    <a:ext cx="437299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e-09</a:t>
                    </a:r>
                  </a:p>
                </p:txBody>
              </p:sp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6832CDF4-152C-1B94-8198-2AE3BD5A84F6}"/>
                      </a:ext>
                    </a:extLst>
                  </p:cNvPr>
                  <p:cNvSpPr txBox="1"/>
                  <p:nvPr/>
                </p:nvSpPr>
                <p:spPr>
                  <a:xfrm>
                    <a:off x="11525420" y="5141078"/>
                    <a:ext cx="437299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e-09</a:t>
                    </a:r>
                  </a:p>
                </p:txBody>
              </p:sp>
            </p:grp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4F0460D2-D4AF-C159-20A0-FBB0821A4C33}"/>
                    </a:ext>
                  </a:extLst>
                </p:cNvPr>
                <p:cNvSpPr txBox="1"/>
                <p:nvPr/>
              </p:nvSpPr>
              <p:spPr>
                <a:xfrm>
                  <a:off x="11366723" y="4633374"/>
                  <a:ext cx="754691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djusted </a:t>
                  </a:r>
                  <a:r>
                    <a:rPr lang="en-US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value</a:t>
                  </a:r>
                </a:p>
              </p:txBody>
            </p:sp>
          </p:grp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1A9B94E-F3D1-37FC-D446-C60C963ECED9}"/>
                </a:ext>
              </a:extLst>
            </p:cNvPr>
            <p:cNvSpPr txBox="1"/>
            <p:nvPr/>
          </p:nvSpPr>
          <p:spPr>
            <a:xfrm>
              <a:off x="9876768" y="4464024"/>
              <a:ext cx="10074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Biological Process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56067A0B-AD9B-24A8-DABA-C227CAA0D9F4}"/>
              </a:ext>
            </a:extLst>
          </p:cNvPr>
          <p:cNvGrpSpPr/>
          <p:nvPr/>
        </p:nvGrpSpPr>
        <p:grpSpPr>
          <a:xfrm>
            <a:off x="1772523" y="1485799"/>
            <a:ext cx="4028841" cy="1293382"/>
            <a:chOff x="8077789" y="3246360"/>
            <a:chExt cx="4028841" cy="1293382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D2C08C77-7878-CAB8-24C7-27C8E2898D91}"/>
                </a:ext>
              </a:extLst>
            </p:cNvPr>
            <p:cNvGrpSpPr/>
            <p:nvPr/>
          </p:nvGrpSpPr>
          <p:grpSpPr>
            <a:xfrm>
              <a:off x="8077789" y="3246360"/>
              <a:ext cx="4028841" cy="1293382"/>
              <a:chOff x="8077789" y="3246360"/>
              <a:chExt cx="4028841" cy="1293382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368B3DA5-FEC7-D8A2-88E4-C9C5193EB22E}"/>
                  </a:ext>
                </a:extLst>
              </p:cNvPr>
              <p:cNvGrpSpPr/>
              <p:nvPr/>
            </p:nvGrpSpPr>
            <p:grpSpPr>
              <a:xfrm>
                <a:off x="8077789" y="3246360"/>
                <a:ext cx="3323636" cy="1293382"/>
                <a:chOff x="8077789" y="3246360"/>
                <a:chExt cx="3323636" cy="1293382"/>
              </a:xfrm>
            </p:grpSpPr>
            <p:grpSp>
              <p:nvGrpSpPr>
                <p:cNvPr id="49" name="Group 48">
                  <a:extLst>
                    <a:ext uri="{FF2B5EF4-FFF2-40B4-BE49-F238E27FC236}">
                      <a16:creationId xmlns:a16="http://schemas.microsoft.com/office/drawing/2014/main" id="{43D9ECA5-4FBD-DC35-D905-FFAABC82B3E8}"/>
                    </a:ext>
                  </a:extLst>
                </p:cNvPr>
                <p:cNvGrpSpPr/>
                <p:nvPr/>
              </p:nvGrpSpPr>
              <p:grpSpPr>
                <a:xfrm>
                  <a:off x="8077789" y="3246360"/>
                  <a:ext cx="3323636" cy="1110481"/>
                  <a:chOff x="8077789" y="3072036"/>
                  <a:chExt cx="3323636" cy="1110481"/>
                </a:xfrm>
              </p:grpSpPr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970B8C2E-C64E-8A4B-7280-6A3DCBA0131B}"/>
                      </a:ext>
                    </a:extLst>
                  </p:cNvPr>
                  <p:cNvSpPr txBox="1"/>
                  <p:nvPr/>
                </p:nvSpPr>
                <p:spPr>
                  <a:xfrm>
                    <a:off x="9201150" y="3929232"/>
                    <a:ext cx="391642" cy="1692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ioma</a:t>
                    </a:r>
                  </a:p>
                </p:txBody>
              </p:sp>
              <p:grpSp>
                <p:nvGrpSpPr>
                  <p:cNvPr id="57" name="Group 56">
                    <a:extLst>
                      <a:ext uri="{FF2B5EF4-FFF2-40B4-BE49-F238E27FC236}">
                        <a16:creationId xmlns:a16="http://schemas.microsoft.com/office/drawing/2014/main" id="{49893612-247D-5113-1B47-47FDD3FBAF42}"/>
                      </a:ext>
                    </a:extLst>
                  </p:cNvPr>
                  <p:cNvGrpSpPr/>
                  <p:nvPr/>
                </p:nvGrpSpPr>
                <p:grpSpPr>
                  <a:xfrm>
                    <a:off x="8077789" y="3072036"/>
                    <a:ext cx="3323636" cy="1110481"/>
                    <a:chOff x="8077789" y="3072036"/>
                    <a:chExt cx="3323636" cy="1110481"/>
                  </a:xfrm>
                </p:grpSpPr>
                <p:grpSp>
                  <p:nvGrpSpPr>
                    <p:cNvPr id="58" name="Group 57">
                      <a:extLst>
                        <a:ext uri="{FF2B5EF4-FFF2-40B4-BE49-F238E27FC236}">
                          <a16:creationId xmlns:a16="http://schemas.microsoft.com/office/drawing/2014/main" id="{39D81721-3DBC-65F0-A3EB-9A505BAE37A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077789" y="3241203"/>
                      <a:ext cx="3323636" cy="941314"/>
                      <a:chOff x="8077789" y="3241203"/>
                      <a:chExt cx="3323636" cy="941314"/>
                    </a:xfrm>
                  </p:grpSpPr>
                  <p:sp>
                    <p:nvSpPr>
                      <p:cNvPr id="60" name="TextBox 59">
                        <a:extLst>
                          <a:ext uri="{FF2B5EF4-FFF2-40B4-BE49-F238E27FC236}">
                            <a16:creationId xmlns:a16="http://schemas.microsoft.com/office/drawing/2014/main" id="{12CE741A-334D-4BAF-B7C6-C8514955B97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063032" y="3405716"/>
                        <a:ext cx="537693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Endocytosis</a:t>
                        </a:r>
                      </a:p>
                    </p:txBody>
                  </p:sp>
                  <p:grpSp>
                    <p:nvGrpSpPr>
                      <p:cNvPr id="61" name="Group 60">
                        <a:extLst>
                          <a:ext uri="{FF2B5EF4-FFF2-40B4-BE49-F238E27FC236}">
                            <a16:creationId xmlns:a16="http://schemas.microsoft.com/office/drawing/2014/main" id="{3229D355-7197-4456-C086-82E0C94254C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077789" y="3241203"/>
                        <a:ext cx="3323636" cy="941314"/>
                        <a:chOff x="8077789" y="3241203"/>
                        <a:chExt cx="3323636" cy="941314"/>
                      </a:xfrm>
                    </p:grpSpPr>
                    <p:pic>
                      <p:nvPicPr>
                        <p:cNvPr id="62" name="Picture 61">
                          <a:extLst>
                            <a:ext uri="{FF2B5EF4-FFF2-40B4-BE49-F238E27FC236}">
                              <a16:creationId xmlns:a16="http://schemas.microsoft.com/office/drawing/2014/main" id="{BF121619-1504-3B20-563A-D0AFC16C4B4F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3"/>
                        <a:srcRect l="24329" t="11350" r="20543" b="18378"/>
                        <a:stretch>
                          <a:fillRect/>
                        </a:stretch>
                      </p:blipFill>
                      <p:spPr>
                        <a:xfrm>
                          <a:off x="9519137" y="3241562"/>
                          <a:ext cx="1882288" cy="930388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63" name="TextBox 62">
                          <a:extLst>
                            <a:ext uri="{FF2B5EF4-FFF2-40B4-BE49-F238E27FC236}">
                              <a16:creationId xmlns:a16="http://schemas.microsoft.com/office/drawing/2014/main" id="{4167FD26-7D59-D637-C650-D74948C1E99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693206" y="3241203"/>
                          <a:ext cx="945623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Hepatocellular carcinoma</a:t>
                          </a:r>
                        </a:p>
                      </p:txBody>
                    </p:sp>
                    <p:sp>
                      <p:nvSpPr>
                        <p:cNvPr id="64" name="TextBox 63">
                          <a:extLst>
                            <a:ext uri="{FF2B5EF4-FFF2-40B4-BE49-F238E27FC236}">
                              <a16:creationId xmlns:a16="http://schemas.microsoft.com/office/drawing/2014/main" id="{EC9131A3-7775-26C2-2365-7916FEE85FA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782052" y="3321078"/>
                          <a:ext cx="866304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pinocerebellar ataxia</a:t>
                          </a:r>
                        </a:p>
                      </p:txBody>
                    </p:sp>
                    <p:sp>
                      <p:nvSpPr>
                        <p:cNvPr id="65" name="TextBox 64">
                          <a:extLst>
                            <a:ext uri="{FF2B5EF4-FFF2-40B4-BE49-F238E27FC236}">
                              <a16:creationId xmlns:a16="http://schemas.microsoft.com/office/drawing/2014/main" id="{23E98769-9231-97E6-CF84-C328C35C9B3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823685" y="3490354"/>
                          <a:ext cx="767513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ellular Senescence</a:t>
                          </a:r>
                        </a:p>
                      </p:txBody>
                    </p:sp>
                    <p:sp>
                      <p:nvSpPr>
                        <p:cNvPr id="66" name="TextBox 65">
                          <a:extLst>
                            <a:ext uri="{FF2B5EF4-FFF2-40B4-BE49-F238E27FC236}">
                              <a16:creationId xmlns:a16="http://schemas.microsoft.com/office/drawing/2014/main" id="{24F59672-17B5-6DEC-A539-00011E29210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707496" y="3575556"/>
                          <a:ext cx="902753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Apelin signaling pathway</a:t>
                          </a:r>
                        </a:p>
                      </p:txBody>
                    </p:sp>
                    <p:sp>
                      <p:nvSpPr>
                        <p:cNvPr id="67" name="TextBox 66">
                          <a:extLst>
                            <a:ext uri="{FF2B5EF4-FFF2-40B4-BE49-F238E27FC236}">
                              <a16:creationId xmlns:a16="http://schemas.microsoft.com/office/drawing/2014/main" id="{1BC52EE4-F95A-CF75-E506-2398439B384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705114" y="3666899"/>
                          <a:ext cx="902753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AMPK signaling pathway</a:t>
                          </a:r>
                        </a:p>
                      </p:txBody>
                    </p:sp>
                    <p:sp>
                      <p:nvSpPr>
                        <p:cNvPr id="68" name="TextBox 67">
                          <a:extLst>
                            <a:ext uri="{FF2B5EF4-FFF2-40B4-BE49-F238E27FC236}">
                              <a16:creationId xmlns:a16="http://schemas.microsoft.com/office/drawing/2014/main" id="{F31A5DE2-21BD-0072-B4B3-8419CB9D9F5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077789" y="3763991"/>
                          <a:ext cx="1508648" cy="15645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>
                            <a:lnSpc>
                              <a:spcPts val="500"/>
                            </a:lnSpc>
                          </a:pPr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Longevity regulating pathway-multiple species</a:t>
                          </a:r>
                        </a:p>
                      </p:txBody>
                    </p:sp>
                    <p:sp>
                      <p:nvSpPr>
                        <p:cNvPr id="69" name="TextBox 68">
                          <a:extLst>
                            <a:ext uri="{FF2B5EF4-FFF2-40B4-BE49-F238E27FC236}">
                              <a16:creationId xmlns:a16="http://schemas.microsoft.com/office/drawing/2014/main" id="{AD49C318-8772-42E6-D3AA-8F15095D2A0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887699" y="3842071"/>
                          <a:ext cx="694842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Autophagy-animal</a:t>
                          </a:r>
                        </a:p>
                      </p:txBody>
                    </p:sp>
                    <p:sp>
                      <p:nvSpPr>
                        <p:cNvPr id="70" name="TextBox 69">
                          <a:extLst>
                            <a:ext uri="{FF2B5EF4-FFF2-40B4-BE49-F238E27FC236}">
                              <a16:creationId xmlns:a16="http://schemas.microsoft.com/office/drawing/2014/main" id="{B938B60F-9336-E3CA-38D0-B753BB979F7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631852" y="4013240"/>
                          <a:ext cx="983768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Oxytocin signaling pathway</a:t>
                          </a:r>
                        </a:p>
                      </p:txBody>
                    </p:sp>
                  </p:grpSp>
                </p:grpSp>
                <p:sp>
                  <p:nvSpPr>
                    <p:cNvPr id="59" name="TextBox 58">
                      <a:extLst>
                        <a:ext uri="{FF2B5EF4-FFF2-40B4-BE49-F238E27FC236}">
                          <a16:creationId xmlns:a16="http://schemas.microsoft.com/office/drawing/2014/main" id="{5388A232-0AE2-903E-5B28-164EC2564F8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131138" y="3072036"/>
                      <a:ext cx="498684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GG</a:t>
                      </a:r>
                    </a:p>
                  </p:txBody>
                </p:sp>
              </p:grpSp>
            </p:grp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AC8DD564-34CF-0D4A-DCAB-5AEED2B8996D}"/>
                    </a:ext>
                  </a:extLst>
                </p:cNvPr>
                <p:cNvSpPr txBox="1"/>
                <p:nvPr/>
              </p:nvSpPr>
              <p:spPr>
                <a:xfrm>
                  <a:off x="9519137" y="4303470"/>
                  <a:ext cx="21757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CDABFE76-7140-C7C0-5CB7-674C80B6855A}"/>
                    </a:ext>
                  </a:extLst>
                </p:cNvPr>
                <p:cNvSpPr txBox="1"/>
                <p:nvPr/>
              </p:nvSpPr>
              <p:spPr>
                <a:xfrm>
                  <a:off x="9862080" y="4302213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5EF34A11-525A-324A-DB3C-DE2B68077E3D}"/>
                    </a:ext>
                  </a:extLst>
                </p:cNvPr>
                <p:cNvSpPr txBox="1"/>
                <p:nvPr/>
              </p:nvSpPr>
              <p:spPr>
                <a:xfrm>
                  <a:off x="10212207" y="4302213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FB9F2861-61EF-D5EA-CF5E-F236DBF4721F}"/>
                    </a:ext>
                  </a:extLst>
                </p:cNvPr>
                <p:cNvSpPr txBox="1"/>
                <p:nvPr/>
              </p:nvSpPr>
              <p:spPr>
                <a:xfrm>
                  <a:off x="10553255" y="4296366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ACA1A6C8-E3D8-E057-482C-CCB0EEB59A98}"/>
                    </a:ext>
                  </a:extLst>
                </p:cNvPr>
                <p:cNvSpPr txBox="1"/>
                <p:nvPr/>
              </p:nvSpPr>
              <p:spPr>
                <a:xfrm>
                  <a:off x="10226697" y="4370465"/>
                  <a:ext cx="754691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60D34567-E3EB-8974-F75A-0843B9C69882}"/>
                    </a:ext>
                  </a:extLst>
                </p:cNvPr>
                <p:cNvSpPr txBox="1"/>
                <p:nvPr/>
              </p:nvSpPr>
              <p:spPr>
                <a:xfrm>
                  <a:off x="10898743" y="4297926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</p:grpSp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97781989-E24C-E993-1C8D-69E37702CBF1}"/>
                  </a:ext>
                </a:extLst>
              </p:cNvPr>
              <p:cNvGrpSpPr/>
              <p:nvPr/>
            </p:nvGrpSpPr>
            <p:grpSpPr>
              <a:xfrm>
                <a:off x="11351939" y="3483441"/>
                <a:ext cx="754691" cy="745873"/>
                <a:chOff x="11351939" y="3483441"/>
                <a:chExt cx="754691" cy="745873"/>
              </a:xfrm>
            </p:grpSpPr>
            <p:pic>
              <p:nvPicPr>
                <p:cNvPr id="43" name="Picture 42">
                  <a:extLst>
                    <a:ext uri="{FF2B5EF4-FFF2-40B4-BE49-F238E27FC236}">
                      <a16:creationId xmlns:a16="http://schemas.microsoft.com/office/drawing/2014/main" id="{31A1900A-69DE-0884-5A9A-F0916236690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rcRect l="81188" t="25211" r="14863" b="20381"/>
                <a:stretch>
                  <a:fillRect/>
                </a:stretch>
              </p:blipFill>
              <p:spPr>
                <a:xfrm>
                  <a:off x="11463888" y="3628104"/>
                  <a:ext cx="113222" cy="601210"/>
                </a:xfrm>
                <a:prstGeom prst="rect">
                  <a:avLst/>
                </a:prstGeom>
              </p:spPr>
            </p:pic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71AF4CDF-9701-D7FF-A4C4-31F3449C5D76}"/>
                    </a:ext>
                  </a:extLst>
                </p:cNvPr>
                <p:cNvSpPr txBox="1"/>
                <p:nvPr/>
              </p:nvSpPr>
              <p:spPr>
                <a:xfrm>
                  <a:off x="11351939" y="3483441"/>
                  <a:ext cx="754691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djusted </a:t>
                  </a:r>
                  <a:r>
                    <a:rPr lang="en-US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value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9EC215EF-16EF-9822-D2E6-D6076B345CE8}"/>
                    </a:ext>
                  </a:extLst>
                </p:cNvPr>
                <p:cNvSpPr txBox="1"/>
                <p:nvPr/>
              </p:nvSpPr>
              <p:spPr>
                <a:xfrm>
                  <a:off x="11509106" y="3653231"/>
                  <a:ext cx="437299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025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BA885100-C391-FD6F-C20A-BE275670F20C}"/>
                    </a:ext>
                  </a:extLst>
                </p:cNvPr>
                <p:cNvSpPr txBox="1"/>
                <p:nvPr/>
              </p:nvSpPr>
              <p:spPr>
                <a:xfrm>
                  <a:off x="11509106" y="3784335"/>
                  <a:ext cx="437299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020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CA2FD7B6-582D-AAEF-0F37-31141EDFA700}"/>
                    </a:ext>
                  </a:extLst>
                </p:cNvPr>
                <p:cNvSpPr txBox="1"/>
                <p:nvPr/>
              </p:nvSpPr>
              <p:spPr>
                <a:xfrm>
                  <a:off x="11505816" y="3905593"/>
                  <a:ext cx="437299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015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B4981A4E-2F22-E185-E562-2D0C1F75D118}"/>
                    </a:ext>
                  </a:extLst>
                </p:cNvPr>
                <p:cNvSpPr txBox="1"/>
                <p:nvPr/>
              </p:nvSpPr>
              <p:spPr>
                <a:xfrm>
                  <a:off x="11505816" y="4041998"/>
                  <a:ext cx="437299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010</a:t>
                  </a:r>
                </a:p>
              </p:txBody>
            </p:sp>
          </p:grpSp>
        </p:grp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B50117A7-8D7B-5AA0-3976-86941D1AB506}"/>
                </a:ext>
              </a:extLst>
            </p:cNvPr>
            <p:cNvCxnSpPr>
              <a:cxnSpLocks/>
            </p:cNvCxnSpPr>
            <p:nvPr/>
          </p:nvCxnSpPr>
          <p:spPr>
            <a:xfrm>
              <a:off x="9595943" y="3454108"/>
              <a:ext cx="0" cy="8686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32BA5B1F-9D02-86B4-BA05-E54A18A8F867}"/>
              </a:ext>
            </a:extLst>
          </p:cNvPr>
          <p:cNvGrpSpPr/>
          <p:nvPr/>
        </p:nvGrpSpPr>
        <p:grpSpPr>
          <a:xfrm>
            <a:off x="1542496" y="4127214"/>
            <a:ext cx="4316844" cy="1397218"/>
            <a:chOff x="7847762" y="5887775"/>
            <a:chExt cx="4316844" cy="1397218"/>
          </a:xfrm>
        </p:grpSpPr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E530416B-7788-3F0C-062B-A13E19BE484A}"/>
                </a:ext>
              </a:extLst>
            </p:cNvPr>
            <p:cNvGrpSpPr/>
            <p:nvPr/>
          </p:nvGrpSpPr>
          <p:grpSpPr>
            <a:xfrm>
              <a:off x="7847762" y="5887775"/>
              <a:ext cx="4316844" cy="1397218"/>
              <a:chOff x="7826982" y="5887775"/>
              <a:chExt cx="4316844" cy="1397218"/>
            </a:xfrm>
          </p:grpSpPr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2B73F43D-EFDF-1862-E355-1D8A7FC2D52E}"/>
                  </a:ext>
                </a:extLst>
              </p:cNvPr>
              <p:cNvSpPr txBox="1"/>
              <p:nvPr/>
            </p:nvSpPr>
            <p:spPr>
              <a:xfrm>
                <a:off x="9913281" y="5887775"/>
                <a:ext cx="100742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olecular Function</a:t>
                </a:r>
              </a:p>
            </p:txBody>
          </p:sp>
          <p:grpSp>
            <p:nvGrpSpPr>
              <p:cNvPr id="75" name="Group 74">
                <a:extLst>
                  <a:ext uri="{FF2B5EF4-FFF2-40B4-BE49-F238E27FC236}">
                    <a16:creationId xmlns:a16="http://schemas.microsoft.com/office/drawing/2014/main" id="{1B99568F-1314-5591-A1EB-D84286769BFB}"/>
                  </a:ext>
                </a:extLst>
              </p:cNvPr>
              <p:cNvGrpSpPr/>
              <p:nvPr/>
            </p:nvGrpSpPr>
            <p:grpSpPr>
              <a:xfrm>
                <a:off x="7826982" y="6062494"/>
                <a:ext cx="4316844" cy="1222499"/>
                <a:chOff x="7826982" y="6062494"/>
                <a:chExt cx="4316844" cy="1222499"/>
              </a:xfrm>
            </p:grpSpPr>
            <p:grpSp>
              <p:nvGrpSpPr>
                <p:cNvPr id="76" name="Group 75">
                  <a:extLst>
                    <a:ext uri="{FF2B5EF4-FFF2-40B4-BE49-F238E27FC236}">
                      <a16:creationId xmlns:a16="http://schemas.microsoft.com/office/drawing/2014/main" id="{E85DB499-D1A4-6C6D-4418-C77B1A2EE8FA}"/>
                    </a:ext>
                  </a:extLst>
                </p:cNvPr>
                <p:cNvGrpSpPr/>
                <p:nvPr/>
              </p:nvGrpSpPr>
              <p:grpSpPr>
                <a:xfrm>
                  <a:off x="7826982" y="6062494"/>
                  <a:ext cx="4316844" cy="1023092"/>
                  <a:chOff x="7826982" y="6062494"/>
                  <a:chExt cx="4316844" cy="1023092"/>
                </a:xfrm>
              </p:grpSpPr>
              <p:grpSp>
                <p:nvGrpSpPr>
                  <p:cNvPr id="82" name="Group 81">
                    <a:extLst>
                      <a:ext uri="{FF2B5EF4-FFF2-40B4-BE49-F238E27FC236}">
                        <a16:creationId xmlns:a16="http://schemas.microsoft.com/office/drawing/2014/main" id="{9649887B-C8EC-C36B-4E65-59E668A7B64E}"/>
                      </a:ext>
                    </a:extLst>
                  </p:cNvPr>
                  <p:cNvGrpSpPr/>
                  <p:nvPr/>
                </p:nvGrpSpPr>
                <p:grpSpPr>
                  <a:xfrm>
                    <a:off x="7826982" y="6062494"/>
                    <a:ext cx="3634396" cy="1023092"/>
                    <a:chOff x="7826982" y="6062494"/>
                    <a:chExt cx="3634396" cy="1023092"/>
                  </a:xfrm>
                </p:grpSpPr>
                <p:pic>
                  <p:nvPicPr>
                    <p:cNvPr id="90" name="Picture 89">
                      <a:extLst>
                        <a:ext uri="{FF2B5EF4-FFF2-40B4-BE49-F238E27FC236}">
                          <a16:creationId xmlns:a16="http://schemas.microsoft.com/office/drawing/2014/main" id="{F75C36D3-EEC4-5769-F2CC-2A50287AC1B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/>
                    <a:srcRect l="24156" t="12971" r="21597" b="17244"/>
                    <a:stretch>
                      <a:fillRect/>
                    </a:stretch>
                  </p:blipFill>
                  <p:spPr>
                    <a:xfrm>
                      <a:off x="9507075" y="6095288"/>
                      <a:ext cx="1954303" cy="990298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91" name="Group 90">
                      <a:extLst>
                        <a:ext uri="{FF2B5EF4-FFF2-40B4-BE49-F238E27FC236}">
                          <a16:creationId xmlns:a16="http://schemas.microsoft.com/office/drawing/2014/main" id="{D6BE2404-A98D-0319-5C1D-5427028A1A7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826982" y="6062494"/>
                      <a:ext cx="1741222" cy="1019634"/>
                      <a:chOff x="7826982" y="6062494"/>
                      <a:chExt cx="1741222" cy="1019634"/>
                    </a:xfrm>
                  </p:grpSpPr>
                  <p:grpSp>
                    <p:nvGrpSpPr>
                      <p:cNvPr id="92" name="Group 91">
                        <a:extLst>
                          <a:ext uri="{FF2B5EF4-FFF2-40B4-BE49-F238E27FC236}">
                            <a16:creationId xmlns:a16="http://schemas.microsoft.com/office/drawing/2014/main" id="{EDBA9ADD-2FC7-E95B-0667-20530FD2B67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7826982" y="6062494"/>
                        <a:ext cx="1741222" cy="923845"/>
                        <a:chOff x="7826982" y="6062494"/>
                        <a:chExt cx="1741222" cy="923845"/>
                      </a:xfrm>
                    </p:grpSpPr>
                    <p:grpSp>
                      <p:nvGrpSpPr>
                        <p:cNvPr id="94" name="Group 93">
                          <a:extLst>
                            <a:ext uri="{FF2B5EF4-FFF2-40B4-BE49-F238E27FC236}">
                              <a16:creationId xmlns:a16="http://schemas.microsoft.com/office/drawing/2014/main" id="{CDCC831E-D1FD-F9A0-24EE-AD4451CFBC63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7826982" y="6062494"/>
                          <a:ext cx="1741222" cy="829623"/>
                          <a:chOff x="7826982" y="6062494"/>
                          <a:chExt cx="1741222" cy="829623"/>
                        </a:xfrm>
                      </p:grpSpPr>
                      <p:grpSp>
                        <p:nvGrpSpPr>
                          <p:cNvPr id="96" name="Group 95">
                            <a:extLst>
                              <a:ext uri="{FF2B5EF4-FFF2-40B4-BE49-F238E27FC236}">
                                <a16:creationId xmlns:a16="http://schemas.microsoft.com/office/drawing/2014/main" id="{4193B6E4-2A5E-5AB3-C330-39E06893DB40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7826982" y="6062494"/>
                            <a:ext cx="1741222" cy="741467"/>
                            <a:chOff x="7826982" y="6062494"/>
                            <a:chExt cx="1741222" cy="741467"/>
                          </a:xfrm>
                        </p:grpSpPr>
                        <p:grpSp>
                          <p:nvGrpSpPr>
                            <p:cNvPr id="98" name="Group 97">
                              <a:extLst>
                                <a:ext uri="{FF2B5EF4-FFF2-40B4-BE49-F238E27FC236}">
                                  <a16:creationId xmlns:a16="http://schemas.microsoft.com/office/drawing/2014/main" id="{F713D74E-4130-C91C-625E-A9352C3C38FB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7826982" y="6062494"/>
                              <a:ext cx="1741222" cy="677194"/>
                              <a:chOff x="7826982" y="6062494"/>
                              <a:chExt cx="1741222" cy="677194"/>
                            </a:xfrm>
                          </p:grpSpPr>
                          <p:grpSp>
                            <p:nvGrpSpPr>
                              <p:cNvPr id="100" name="Group 99">
                                <a:extLst>
                                  <a:ext uri="{FF2B5EF4-FFF2-40B4-BE49-F238E27FC236}">
                                    <a16:creationId xmlns:a16="http://schemas.microsoft.com/office/drawing/2014/main" id="{EF5F87D5-2128-C3B1-984B-5ABCC5EB23F4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8131303" y="6062494"/>
                                <a:ext cx="1436901" cy="544712"/>
                                <a:chOff x="8131303" y="6062494"/>
                                <a:chExt cx="1436901" cy="544712"/>
                              </a:xfrm>
                            </p:grpSpPr>
                            <p:grpSp>
                              <p:nvGrpSpPr>
                                <p:cNvPr id="102" name="Group 101">
                                  <a:extLst>
                                    <a:ext uri="{FF2B5EF4-FFF2-40B4-BE49-F238E27FC236}">
                                      <a16:creationId xmlns:a16="http://schemas.microsoft.com/office/drawing/2014/main" id="{7377BF72-FB69-FA99-89C5-C51B653B3A71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8131303" y="6062494"/>
                                  <a:ext cx="1436901" cy="437029"/>
                                  <a:chOff x="8131303" y="6062494"/>
                                  <a:chExt cx="1436901" cy="437029"/>
                                </a:xfrm>
                              </p:grpSpPr>
                              <p:sp>
                                <p:nvSpPr>
                                  <p:cNvPr id="104" name="TextBox 103">
                                    <a:extLst>
                                      <a:ext uri="{FF2B5EF4-FFF2-40B4-BE49-F238E27FC236}">
                                        <a16:creationId xmlns:a16="http://schemas.microsoft.com/office/drawing/2014/main" id="{DA1CC839-87DA-4C81-48C1-4FB858F0A8EE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8442907" y="6062494"/>
                                    <a:ext cx="1125297" cy="169277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square" rtlCol="0">
                                    <a:spAutoFit/>
                                  </a:bodyPr>
                                  <a:lstStyle/>
                                  <a:p>
                                    <a:pPr algn="r"/>
                                    <a:r>
                                      <a:rPr lang="en-US" sz="500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Transcription coregulator activity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05" name="TextBox 104">
                                    <a:extLst>
                                      <a:ext uri="{FF2B5EF4-FFF2-40B4-BE49-F238E27FC236}">
                                        <a16:creationId xmlns:a16="http://schemas.microsoft.com/office/drawing/2014/main" id="{96954703-E5B3-88B7-0148-71DA4C57B595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8131303" y="6268023"/>
                                    <a:ext cx="1432420" cy="14542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square" rtlCol="0">
                                    <a:spAutoFit/>
                                  </a:bodyPr>
                                  <a:lstStyle/>
                                  <a:p>
                                    <a:pPr algn="r">
                                      <a:lnSpc>
                                        <a:spcPts val="400"/>
                                      </a:lnSpc>
                                    </a:pPr>
                                    <a:r>
                                      <a:rPr lang="en-US" sz="500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Nucleoside triphosphatase regulator activity</a:t>
                                    </a:r>
                                  </a:p>
                                </p:txBody>
                              </p:sp>
                              <p:sp>
                                <p:nvSpPr>
                                  <p:cNvPr id="106" name="TextBox 105">
                                    <a:extLst>
                                      <a:ext uri="{FF2B5EF4-FFF2-40B4-BE49-F238E27FC236}">
                                        <a16:creationId xmlns:a16="http://schemas.microsoft.com/office/drawing/2014/main" id="{19A83C4A-0A4B-3974-5821-744A56724063}"/>
                                      </a:ext>
                                    </a:extLst>
                                  </p:cNvPr>
                                  <p:cNvSpPr txBox="1"/>
                                  <p:nvPr/>
                                </p:nvSpPr>
                                <p:spPr>
                                  <a:xfrm>
                                    <a:off x="8294245" y="6354099"/>
                                    <a:ext cx="1264996" cy="145424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square" rtlCol="0">
                                    <a:spAutoFit/>
                                  </a:bodyPr>
                                  <a:lstStyle/>
                                  <a:p>
                                    <a:pPr algn="r">
                                      <a:lnSpc>
                                        <a:spcPts val="400"/>
                                      </a:lnSpc>
                                    </a:pPr>
                                    <a:r>
                                      <a:rPr lang="en-US" sz="500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Protein serine/threonine kinase activity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103" name="TextBox 102">
                                  <a:extLst>
                                    <a:ext uri="{FF2B5EF4-FFF2-40B4-BE49-F238E27FC236}">
                                      <a16:creationId xmlns:a16="http://schemas.microsoft.com/office/drawing/2014/main" id="{4F3BECE7-174E-29F3-0F17-5DA31CFA8DA7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8427692" y="6437929"/>
                                  <a:ext cx="1125297" cy="169277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r"/>
                                  <a:r>
                                    <a:rPr lang="en-US" sz="5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Small GTPase binding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101" name="TextBox 100">
                                <a:extLst>
                                  <a:ext uri="{FF2B5EF4-FFF2-40B4-BE49-F238E27FC236}">
                                    <a16:creationId xmlns:a16="http://schemas.microsoft.com/office/drawing/2014/main" id="{D336E3E1-AE18-EEE0-553B-55648D2ECB0C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7826982" y="6519115"/>
                                <a:ext cx="1732257" cy="220573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pPr algn="r">
                                  <a:lnSpc>
                                    <a:spcPts val="500"/>
                                  </a:lnSpc>
                                </a:pPr>
                                <a:r>
                                  <a:rPr lang="en-US" sz="5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rPr>
                                  <a:t>RNA polymerase II-specific DNA-binding transcription factor binding</a:t>
                                </a:r>
                              </a:p>
                            </p:txBody>
                          </p:sp>
                        </p:grpSp>
                        <p:sp>
                          <p:nvSpPr>
                            <p:cNvPr id="99" name="TextBox 98">
                              <a:extLst>
                                <a:ext uri="{FF2B5EF4-FFF2-40B4-BE49-F238E27FC236}">
                                  <a16:creationId xmlns:a16="http://schemas.microsoft.com/office/drawing/2014/main" id="{EC915436-A7F8-EC3A-4B68-BB741211BD15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8433941" y="6634684"/>
                              <a:ext cx="1125297" cy="1692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r"/>
                              <a:r>
                                <a:rPr lang="en-US" sz="5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Protein serine kinase activity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97" name="TextBox 96">
                            <a:extLst>
                              <a:ext uri="{FF2B5EF4-FFF2-40B4-BE49-F238E27FC236}">
                                <a16:creationId xmlns:a16="http://schemas.microsoft.com/office/drawing/2014/main" id="{858A2D9B-27D9-B2F8-CF9D-4729B5A0176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433940" y="6722840"/>
                            <a:ext cx="1125297" cy="1692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r"/>
                            <a:r>
                              <a:rPr lang="en-US" sz="5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Transcription corepressor activity</a:t>
                            </a:r>
                          </a:p>
                        </p:txBody>
                      </p:sp>
                    </p:grpSp>
                    <p:sp>
                      <p:nvSpPr>
                        <p:cNvPr id="95" name="TextBox 94">
                          <a:extLst>
                            <a:ext uri="{FF2B5EF4-FFF2-40B4-BE49-F238E27FC236}">
                              <a16:creationId xmlns:a16="http://schemas.microsoft.com/office/drawing/2014/main" id="{22FF4A05-AF53-16F0-1037-8E5AFD1B851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8433940" y="6817062"/>
                          <a:ext cx="1125297" cy="1692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GTPase binding</a:t>
                          </a:r>
                        </a:p>
                      </p:txBody>
                    </p:sp>
                  </p:grpSp>
                  <p:sp>
                    <p:nvSpPr>
                      <p:cNvPr id="93" name="TextBox 92">
                        <a:extLst>
                          <a:ext uri="{FF2B5EF4-FFF2-40B4-BE49-F238E27FC236}">
                            <a16:creationId xmlns:a16="http://schemas.microsoft.com/office/drawing/2014/main" id="{2481B313-55DE-68C7-7C96-F9214CA4F1F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083223" y="6936704"/>
                        <a:ext cx="1476014" cy="14542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>
                          <a:lnSpc>
                            <a:spcPts val="400"/>
                          </a:lnSpc>
                        </a:pPr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uanyl-nucleotide exchange factor activity</a:t>
                        </a:r>
                      </a:p>
                    </p:txBody>
                  </p:sp>
                </p:grpSp>
              </p:grpSp>
              <p:grpSp>
                <p:nvGrpSpPr>
                  <p:cNvPr id="83" name="Group 82">
                    <a:extLst>
                      <a:ext uri="{FF2B5EF4-FFF2-40B4-BE49-F238E27FC236}">
                        <a16:creationId xmlns:a16="http://schemas.microsoft.com/office/drawing/2014/main" id="{8BF1F9B9-16C8-CD2C-DF68-06EB561B417A}"/>
                      </a:ext>
                    </a:extLst>
                  </p:cNvPr>
                  <p:cNvGrpSpPr/>
                  <p:nvPr/>
                </p:nvGrpSpPr>
                <p:grpSpPr>
                  <a:xfrm>
                    <a:off x="11389135" y="6141144"/>
                    <a:ext cx="754691" cy="756700"/>
                    <a:chOff x="11389135" y="6141144"/>
                    <a:chExt cx="754691" cy="756700"/>
                  </a:xfrm>
                </p:grpSpPr>
                <p:grpSp>
                  <p:nvGrpSpPr>
                    <p:cNvPr id="84" name="Group 83">
                      <a:extLst>
                        <a:ext uri="{FF2B5EF4-FFF2-40B4-BE49-F238E27FC236}">
                          <a16:creationId xmlns:a16="http://schemas.microsoft.com/office/drawing/2014/main" id="{04428EF8-0BC8-BC3B-A403-278D732CC8E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497235" y="6283030"/>
                      <a:ext cx="489492" cy="614814"/>
                      <a:chOff x="11497235" y="6283030"/>
                      <a:chExt cx="489492" cy="614814"/>
                    </a:xfrm>
                  </p:grpSpPr>
                  <p:pic>
                    <p:nvPicPr>
                      <p:cNvPr id="86" name="Picture 85">
                        <a:extLst>
                          <a:ext uri="{FF2B5EF4-FFF2-40B4-BE49-F238E27FC236}">
                            <a16:creationId xmlns:a16="http://schemas.microsoft.com/office/drawing/2014/main" id="{B23B3EB2-9FEA-A791-5E4A-F053DDAD5B85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4"/>
                      <a:srcRect l="81449" t="26217" r="14694" b="21233"/>
                      <a:stretch>
                        <a:fillRect/>
                      </a:stretch>
                    </p:blipFill>
                    <p:spPr>
                      <a:xfrm>
                        <a:off x="11497235" y="6283030"/>
                        <a:ext cx="121019" cy="614814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87" name="TextBox 86">
                        <a:extLst>
                          <a:ext uri="{FF2B5EF4-FFF2-40B4-BE49-F238E27FC236}">
                            <a16:creationId xmlns:a16="http://schemas.microsoft.com/office/drawing/2014/main" id="{2CD7E8D4-F948-7C8F-182C-6477B014EF4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549428" y="6343556"/>
                        <a:ext cx="437299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.2e-07</a:t>
                        </a:r>
                      </a:p>
                    </p:txBody>
                  </p:sp>
                  <p:sp>
                    <p:nvSpPr>
                      <p:cNvPr id="88" name="TextBox 87">
                        <a:extLst>
                          <a:ext uri="{FF2B5EF4-FFF2-40B4-BE49-F238E27FC236}">
                            <a16:creationId xmlns:a16="http://schemas.microsoft.com/office/drawing/2014/main" id="{5F9915CB-EADB-2D24-D49A-23CF428D954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549427" y="6493505"/>
                        <a:ext cx="437299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8.0e-08</a:t>
                        </a:r>
                      </a:p>
                    </p:txBody>
                  </p:sp>
                  <p:sp>
                    <p:nvSpPr>
                      <p:cNvPr id="89" name="TextBox 88">
                        <a:extLst>
                          <a:ext uri="{FF2B5EF4-FFF2-40B4-BE49-F238E27FC236}">
                            <a16:creationId xmlns:a16="http://schemas.microsoft.com/office/drawing/2014/main" id="{465BB41F-5553-A899-E0D0-FEA88D2E2FB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547832" y="6643837"/>
                        <a:ext cx="437299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.0e-08</a:t>
                        </a:r>
                      </a:p>
                    </p:txBody>
                  </p:sp>
                </p:grpSp>
                <p:sp>
                  <p:nvSpPr>
                    <p:cNvPr id="85" name="TextBox 84">
                      <a:extLst>
                        <a:ext uri="{FF2B5EF4-FFF2-40B4-BE49-F238E27FC236}">
                          <a16:creationId xmlns:a16="http://schemas.microsoft.com/office/drawing/2014/main" id="{C61A2BB6-8798-91B0-5669-2DDBB50AE9D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389135" y="6141144"/>
                      <a:ext cx="754691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 </a:t>
                      </a:r>
                      <a:r>
                        <a:rPr lang="en-US" sz="5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alue</a:t>
                      </a:r>
                    </a:p>
                  </p:txBody>
                </p:sp>
              </p:grpSp>
            </p:grp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B02906C1-F96B-DD20-B306-2DD2F1B45D32}"/>
                    </a:ext>
                  </a:extLst>
                </p:cNvPr>
                <p:cNvSpPr txBox="1"/>
                <p:nvPr/>
              </p:nvSpPr>
              <p:spPr>
                <a:xfrm>
                  <a:off x="9500229" y="7048721"/>
                  <a:ext cx="21757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F3336E67-6395-6E5A-4A9B-FFD8F4D52B86}"/>
                    </a:ext>
                  </a:extLst>
                </p:cNvPr>
                <p:cNvSpPr txBox="1"/>
                <p:nvPr/>
              </p:nvSpPr>
              <p:spPr>
                <a:xfrm>
                  <a:off x="9994689" y="7046743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9C32C499-7163-A9E5-FD95-AA6ED97AAB18}"/>
                    </a:ext>
                  </a:extLst>
                </p:cNvPr>
                <p:cNvSpPr txBox="1"/>
                <p:nvPr/>
              </p:nvSpPr>
              <p:spPr>
                <a:xfrm>
                  <a:off x="10507702" y="7040041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F014446F-6971-E0C3-F89A-5CC7D3A75E48}"/>
                    </a:ext>
                  </a:extLst>
                </p:cNvPr>
                <p:cNvSpPr txBox="1"/>
                <p:nvPr/>
              </p:nvSpPr>
              <p:spPr>
                <a:xfrm>
                  <a:off x="10147592" y="7115716"/>
                  <a:ext cx="38408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24740BEA-1322-8BB9-CA84-6C460F3D1C33}"/>
                    </a:ext>
                  </a:extLst>
                </p:cNvPr>
                <p:cNvSpPr txBox="1"/>
                <p:nvPr/>
              </p:nvSpPr>
              <p:spPr>
                <a:xfrm>
                  <a:off x="11007429" y="7040040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</p:grpSp>
        </p:grp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9173A5E9-1EFB-6BAA-7E57-33F732911CEB}"/>
                </a:ext>
              </a:extLst>
            </p:cNvPr>
            <p:cNvCxnSpPr>
              <a:cxnSpLocks/>
            </p:cNvCxnSpPr>
            <p:nvPr/>
          </p:nvCxnSpPr>
          <p:spPr>
            <a:xfrm>
              <a:off x="9595128" y="6113663"/>
              <a:ext cx="0" cy="9326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7" name="Group 106">
            <a:extLst>
              <a:ext uri="{FF2B5EF4-FFF2-40B4-BE49-F238E27FC236}">
                <a16:creationId xmlns:a16="http://schemas.microsoft.com/office/drawing/2014/main" id="{1ED8EC6A-EEAE-1C1A-0495-113133A09EE2}"/>
              </a:ext>
            </a:extLst>
          </p:cNvPr>
          <p:cNvGrpSpPr/>
          <p:nvPr/>
        </p:nvGrpSpPr>
        <p:grpSpPr>
          <a:xfrm>
            <a:off x="1592738" y="5609224"/>
            <a:ext cx="4306780" cy="1291239"/>
            <a:chOff x="7898004" y="7369785"/>
            <a:chExt cx="4306780" cy="1291239"/>
          </a:xfrm>
        </p:grpSpPr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8A51D75D-9C42-33EB-184C-F4C6AEEE620C}"/>
                </a:ext>
              </a:extLst>
            </p:cNvPr>
            <p:cNvGrpSpPr/>
            <p:nvPr/>
          </p:nvGrpSpPr>
          <p:grpSpPr>
            <a:xfrm>
              <a:off x="7898004" y="7369785"/>
              <a:ext cx="4306780" cy="1291239"/>
              <a:chOff x="7881380" y="7369785"/>
              <a:chExt cx="4306780" cy="1291239"/>
            </a:xfrm>
          </p:grpSpPr>
          <p:grpSp>
            <p:nvGrpSpPr>
              <p:cNvPr id="110" name="Group 109">
                <a:extLst>
                  <a:ext uri="{FF2B5EF4-FFF2-40B4-BE49-F238E27FC236}">
                    <a16:creationId xmlns:a16="http://schemas.microsoft.com/office/drawing/2014/main" id="{CAB10D51-42FD-FAB9-5CC3-9EAC43F4E51B}"/>
                  </a:ext>
                </a:extLst>
              </p:cNvPr>
              <p:cNvGrpSpPr/>
              <p:nvPr/>
            </p:nvGrpSpPr>
            <p:grpSpPr>
              <a:xfrm>
                <a:off x="7881380" y="7369785"/>
                <a:ext cx="3630095" cy="1291239"/>
                <a:chOff x="7881380" y="7369785"/>
                <a:chExt cx="3630095" cy="1291239"/>
              </a:xfrm>
            </p:grpSpPr>
            <p:grpSp>
              <p:nvGrpSpPr>
                <p:cNvPr id="117" name="Group 116">
                  <a:extLst>
                    <a:ext uri="{FF2B5EF4-FFF2-40B4-BE49-F238E27FC236}">
                      <a16:creationId xmlns:a16="http://schemas.microsoft.com/office/drawing/2014/main" id="{7FA7C995-CD03-BB0A-9C25-F1FD06C896B5}"/>
                    </a:ext>
                  </a:extLst>
                </p:cNvPr>
                <p:cNvGrpSpPr/>
                <p:nvPr/>
              </p:nvGrpSpPr>
              <p:grpSpPr>
                <a:xfrm>
                  <a:off x="7881380" y="7369785"/>
                  <a:ext cx="3630095" cy="1094841"/>
                  <a:chOff x="7881380" y="7369785"/>
                  <a:chExt cx="3630095" cy="1094841"/>
                </a:xfrm>
              </p:grpSpPr>
              <p:grpSp>
                <p:nvGrpSpPr>
                  <p:cNvPr id="123" name="Group 122">
                    <a:extLst>
                      <a:ext uri="{FF2B5EF4-FFF2-40B4-BE49-F238E27FC236}">
                        <a16:creationId xmlns:a16="http://schemas.microsoft.com/office/drawing/2014/main" id="{1166B677-8929-4EC1-026F-E5F69D6EE377}"/>
                      </a:ext>
                    </a:extLst>
                  </p:cNvPr>
                  <p:cNvGrpSpPr/>
                  <p:nvPr/>
                </p:nvGrpSpPr>
                <p:grpSpPr>
                  <a:xfrm>
                    <a:off x="9491715" y="7369785"/>
                    <a:ext cx="2019760" cy="1087497"/>
                    <a:chOff x="9491715" y="7369785"/>
                    <a:chExt cx="2019760" cy="1087497"/>
                  </a:xfrm>
                </p:grpSpPr>
                <p:pic>
                  <p:nvPicPr>
                    <p:cNvPr id="141" name="Picture 140">
                      <a:extLst>
                        <a:ext uri="{FF2B5EF4-FFF2-40B4-BE49-F238E27FC236}">
                          <a16:creationId xmlns:a16="http://schemas.microsoft.com/office/drawing/2014/main" id="{301CB01B-8EB1-AF9B-0439-D2D2B594221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/>
                    <a:srcRect l="18778" t="12436" r="21537" b="16415"/>
                    <a:stretch>
                      <a:fillRect/>
                    </a:stretch>
                  </p:blipFill>
                  <p:spPr>
                    <a:xfrm>
                      <a:off x="9491715" y="7572260"/>
                      <a:ext cx="2019760" cy="88502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2" name="TextBox 141">
                      <a:extLst>
                        <a:ext uri="{FF2B5EF4-FFF2-40B4-BE49-F238E27FC236}">
                          <a16:creationId xmlns:a16="http://schemas.microsoft.com/office/drawing/2014/main" id="{8609D138-DE70-BEC5-36D7-F8C067EA183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876768" y="7369785"/>
                      <a:ext cx="100742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ular Component</a:t>
                      </a:r>
                    </a:p>
                  </p:txBody>
                </p:sp>
              </p:grpSp>
              <p:grpSp>
                <p:nvGrpSpPr>
                  <p:cNvPr id="124" name="Group 123">
                    <a:extLst>
                      <a:ext uri="{FF2B5EF4-FFF2-40B4-BE49-F238E27FC236}">
                        <a16:creationId xmlns:a16="http://schemas.microsoft.com/office/drawing/2014/main" id="{03876709-D69C-8AC5-3643-C1826576B765}"/>
                      </a:ext>
                    </a:extLst>
                  </p:cNvPr>
                  <p:cNvGrpSpPr/>
                  <p:nvPr/>
                </p:nvGrpSpPr>
                <p:grpSpPr>
                  <a:xfrm>
                    <a:off x="7881380" y="7558412"/>
                    <a:ext cx="1671325" cy="906214"/>
                    <a:chOff x="7881380" y="7558412"/>
                    <a:chExt cx="1671325" cy="906214"/>
                  </a:xfrm>
                </p:grpSpPr>
                <p:grpSp>
                  <p:nvGrpSpPr>
                    <p:cNvPr id="125" name="Group 124">
                      <a:extLst>
                        <a:ext uri="{FF2B5EF4-FFF2-40B4-BE49-F238E27FC236}">
                          <a16:creationId xmlns:a16="http://schemas.microsoft.com/office/drawing/2014/main" id="{8F2252B5-399F-6F30-B1D2-C7842FEFBAA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881380" y="7558412"/>
                      <a:ext cx="1667653" cy="827175"/>
                      <a:chOff x="7881380" y="7558412"/>
                      <a:chExt cx="1667653" cy="827175"/>
                    </a:xfrm>
                  </p:grpSpPr>
                  <p:grpSp>
                    <p:nvGrpSpPr>
                      <p:cNvPr id="127" name="Group 126">
                        <a:extLst>
                          <a:ext uri="{FF2B5EF4-FFF2-40B4-BE49-F238E27FC236}">
                            <a16:creationId xmlns:a16="http://schemas.microsoft.com/office/drawing/2014/main" id="{96BE35FB-AB99-8641-7241-CA95E0FBAE3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7881380" y="7558412"/>
                        <a:ext cx="1667653" cy="735542"/>
                        <a:chOff x="7881380" y="7558412"/>
                        <a:chExt cx="1667653" cy="735542"/>
                      </a:xfrm>
                    </p:grpSpPr>
                    <p:grpSp>
                      <p:nvGrpSpPr>
                        <p:cNvPr id="129" name="Group 128">
                          <a:extLst>
                            <a:ext uri="{FF2B5EF4-FFF2-40B4-BE49-F238E27FC236}">
                              <a16:creationId xmlns:a16="http://schemas.microsoft.com/office/drawing/2014/main" id="{6F079260-FCB4-9DC4-D50D-8291BDDBD844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8248147" y="7558412"/>
                          <a:ext cx="1300886" cy="647725"/>
                          <a:chOff x="8248147" y="7558412"/>
                          <a:chExt cx="1300886" cy="647725"/>
                        </a:xfrm>
                      </p:grpSpPr>
                      <p:grpSp>
                        <p:nvGrpSpPr>
                          <p:cNvPr id="131" name="Group 130">
                            <a:extLst>
                              <a:ext uri="{FF2B5EF4-FFF2-40B4-BE49-F238E27FC236}">
                                <a16:creationId xmlns:a16="http://schemas.microsoft.com/office/drawing/2014/main" id="{295045E2-0F64-089B-C3D2-4D5DBFC6CF35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8248147" y="7558412"/>
                            <a:ext cx="1300886" cy="563997"/>
                            <a:chOff x="8248147" y="7558412"/>
                            <a:chExt cx="1300886" cy="563997"/>
                          </a:xfrm>
                        </p:grpSpPr>
                        <p:grpSp>
                          <p:nvGrpSpPr>
                            <p:cNvPr id="133" name="Group 132">
                              <a:extLst>
                                <a:ext uri="{FF2B5EF4-FFF2-40B4-BE49-F238E27FC236}">
                                  <a16:creationId xmlns:a16="http://schemas.microsoft.com/office/drawing/2014/main" id="{6759D149-C07E-561D-614E-A55C05B47009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8248147" y="7558412"/>
                              <a:ext cx="1300886" cy="480328"/>
                              <a:chOff x="8248147" y="7558412"/>
                              <a:chExt cx="1300886" cy="480328"/>
                            </a:xfrm>
                          </p:grpSpPr>
                          <p:grpSp>
                            <p:nvGrpSpPr>
                              <p:cNvPr id="135" name="Group 134">
                                <a:extLst>
                                  <a:ext uri="{FF2B5EF4-FFF2-40B4-BE49-F238E27FC236}">
                                    <a16:creationId xmlns:a16="http://schemas.microsoft.com/office/drawing/2014/main" id="{5FF5D64D-A608-918A-E6EC-CB47A3516B32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8248147" y="7558412"/>
                                <a:ext cx="1300886" cy="315629"/>
                                <a:chOff x="8248147" y="7558412"/>
                                <a:chExt cx="1300886" cy="315629"/>
                              </a:xfrm>
                            </p:grpSpPr>
                            <p:sp>
                              <p:nvSpPr>
                                <p:cNvPr id="138" name="TextBox 137">
                                  <a:extLst>
                                    <a:ext uri="{FF2B5EF4-FFF2-40B4-BE49-F238E27FC236}">
                                      <a16:creationId xmlns:a16="http://schemas.microsoft.com/office/drawing/2014/main" id="{47549DA6-E171-6321-1FF7-C1F63A0387EB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8729032" y="7558412"/>
                                  <a:ext cx="820000" cy="14542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r">
                                    <a:lnSpc>
                                      <a:spcPts val="400"/>
                                    </a:lnSpc>
                                  </a:pPr>
                                  <a:r>
                                    <a:rPr lang="en-US" sz="5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Cell leading edge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39" name="TextBox 138">
                                  <a:extLst>
                                    <a:ext uri="{FF2B5EF4-FFF2-40B4-BE49-F238E27FC236}">
                                      <a16:creationId xmlns:a16="http://schemas.microsoft.com/office/drawing/2014/main" id="{6068FE0A-B61D-69E1-37F7-7A31DF26F289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8729032" y="7644972"/>
                                  <a:ext cx="820000" cy="14542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r">
                                    <a:lnSpc>
                                      <a:spcPts val="400"/>
                                    </a:lnSpc>
                                  </a:pPr>
                                  <a:r>
                                    <a:rPr lang="en-US" sz="5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Cell cortex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140" name="TextBox 139">
                                  <a:extLst>
                                    <a:ext uri="{FF2B5EF4-FFF2-40B4-BE49-F238E27FC236}">
                                      <a16:creationId xmlns:a16="http://schemas.microsoft.com/office/drawing/2014/main" id="{ECD00A58-1907-6A48-6C48-037E48B57C20}"/>
                                    </a:ext>
                                  </a:extLst>
                                </p:cNvPr>
                                <p:cNvSpPr txBox="1"/>
                                <p:nvPr/>
                              </p:nvSpPr>
                              <p:spPr>
                                <a:xfrm>
                                  <a:off x="8248147" y="7728617"/>
                                  <a:ext cx="1300886" cy="14542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r">
                                    <a:lnSpc>
                                      <a:spcPts val="400"/>
                                    </a:lnSpc>
                                  </a:pPr>
                                  <a:r>
                                    <a:rPr lang="en-US" sz="5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Collagen containing extracellular matrix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136" name="TextBox 135">
                                <a:extLst>
                                  <a:ext uri="{FF2B5EF4-FFF2-40B4-BE49-F238E27FC236}">
                                    <a16:creationId xmlns:a16="http://schemas.microsoft.com/office/drawing/2014/main" id="{B61C3576-97D9-C99B-D7F9-157EF63B682D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9188066" y="7813319"/>
                                <a:ext cx="360965" cy="14542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pPr algn="r">
                                  <a:lnSpc>
                                    <a:spcPts val="400"/>
                                  </a:lnSpc>
                                </a:pPr>
                                <a:r>
                                  <a:rPr lang="en-US" sz="5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rPr>
                                  <a:t>Ruffle</a:t>
                                </a:r>
                              </a:p>
                            </p:txBody>
                          </p:sp>
                          <p:sp>
                            <p:nvSpPr>
                              <p:cNvPr id="137" name="TextBox 136">
                                <a:extLst>
                                  <a:ext uri="{FF2B5EF4-FFF2-40B4-BE49-F238E27FC236}">
                                    <a16:creationId xmlns:a16="http://schemas.microsoft.com/office/drawing/2014/main" id="{2AB812FB-4FD4-4842-C65C-656FF89DD234}"/>
                                  </a:ext>
                                </a:extLst>
                              </p:cNvPr>
                              <p:cNvSpPr txBox="1"/>
                              <p:nvPr/>
                            </p:nvSpPr>
                            <p:spPr>
                              <a:xfrm>
                                <a:off x="9099933" y="7893316"/>
                                <a:ext cx="449097" cy="145424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pPr algn="r">
                                  <a:lnSpc>
                                    <a:spcPts val="400"/>
                                  </a:lnSpc>
                                </a:pPr>
                                <a:r>
                                  <a:rPr lang="en-US" sz="5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rPr>
                                  <a:t>Spindle</a:t>
                                </a:r>
                              </a:p>
                            </p:txBody>
                          </p:sp>
                        </p:grpSp>
                        <p:sp>
                          <p:nvSpPr>
                            <p:cNvPr id="134" name="TextBox 133">
                              <a:extLst>
                                <a:ext uri="{FF2B5EF4-FFF2-40B4-BE49-F238E27FC236}">
                                  <a16:creationId xmlns:a16="http://schemas.microsoft.com/office/drawing/2014/main" id="{077399DE-7287-B48C-75B0-A91145EB8797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8762085" y="7976985"/>
                              <a:ext cx="786946" cy="145424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r">
                                <a:lnSpc>
                                  <a:spcPts val="400"/>
                                </a:lnSpc>
                              </a:pPr>
                              <a:r>
                                <a:rPr lang="en-US" sz="5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Vacuolar membrane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132" name="TextBox 131">
                            <a:extLst>
                              <a:ext uri="{FF2B5EF4-FFF2-40B4-BE49-F238E27FC236}">
                                <a16:creationId xmlns:a16="http://schemas.microsoft.com/office/drawing/2014/main" id="{CF48D5A5-FF59-40B8-D61A-A3237BAF732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8762087" y="8060713"/>
                            <a:ext cx="786946" cy="14542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r">
                              <a:lnSpc>
                                <a:spcPts val="400"/>
                              </a:lnSpc>
                            </a:pPr>
                            <a:r>
                              <a:rPr lang="en-US" sz="5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Lamellipodium</a:t>
                            </a:r>
                          </a:p>
                        </p:txBody>
                      </p:sp>
                    </p:grpSp>
                    <p:sp>
                      <p:nvSpPr>
                        <p:cNvPr id="130" name="TextBox 129">
                          <a:extLst>
                            <a:ext uri="{FF2B5EF4-FFF2-40B4-BE49-F238E27FC236}">
                              <a16:creationId xmlns:a16="http://schemas.microsoft.com/office/drawing/2014/main" id="{05AD6AFC-077B-F80F-325F-6D32DAD0FA9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881380" y="8148530"/>
                          <a:ext cx="1667653" cy="14542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>
                            <a:lnSpc>
                              <a:spcPts val="400"/>
                            </a:lnSpc>
                          </a:pPr>
                          <a:r>
                            <a:rPr lang="en-US" sz="5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RNA polymerase II transcription regulator complex</a:t>
                          </a:r>
                        </a:p>
                      </p:txBody>
                    </p:sp>
                  </p:grpSp>
                  <p:sp>
                    <p:nvSpPr>
                      <p:cNvPr id="128" name="TextBox 127">
                        <a:extLst>
                          <a:ext uri="{FF2B5EF4-FFF2-40B4-BE49-F238E27FC236}">
                            <a16:creationId xmlns:a16="http://schemas.microsoft.com/office/drawing/2014/main" id="{012A3BD4-94A0-E73B-98A5-3C79D5D2259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762087" y="8240163"/>
                        <a:ext cx="786946" cy="14542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>
                          <a:lnSpc>
                            <a:spcPts val="400"/>
                          </a:lnSpc>
                        </a:pPr>
                        <a:r>
                          <a:rPr lang="en-US" sz="5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icrotubule</a:t>
                        </a:r>
                      </a:p>
                    </p:txBody>
                  </p:sp>
                </p:grpSp>
                <p:sp>
                  <p:nvSpPr>
                    <p:cNvPr id="126" name="TextBox 125">
                      <a:extLst>
                        <a:ext uri="{FF2B5EF4-FFF2-40B4-BE49-F238E27FC236}">
                          <a16:creationId xmlns:a16="http://schemas.microsoft.com/office/drawing/2014/main" id="{2BA3C801-B235-1BAF-9031-AD69E73A595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765759" y="8319202"/>
                      <a:ext cx="786946" cy="14542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>
                        <a:lnSpc>
                          <a:spcPts val="400"/>
                        </a:lnSpc>
                      </a:pPr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e endosome</a:t>
                      </a:r>
                    </a:p>
                  </p:txBody>
                </p:sp>
              </p:grpSp>
            </p:grpSp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81510D08-C9B1-68D0-8EFE-6ABD6DA5EFEA}"/>
                    </a:ext>
                  </a:extLst>
                </p:cNvPr>
                <p:cNvSpPr txBox="1"/>
                <p:nvPr/>
              </p:nvSpPr>
              <p:spPr>
                <a:xfrm>
                  <a:off x="9502731" y="8424752"/>
                  <a:ext cx="21757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D94382BC-85FE-0042-09BB-43B590F9120E}"/>
                    </a:ext>
                  </a:extLst>
                </p:cNvPr>
                <p:cNvSpPr txBox="1"/>
                <p:nvPr/>
              </p:nvSpPr>
              <p:spPr>
                <a:xfrm>
                  <a:off x="9997191" y="8422774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03396A97-27B7-334D-AFAA-656483B08F73}"/>
                    </a:ext>
                  </a:extLst>
                </p:cNvPr>
                <p:cNvSpPr txBox="1"/>
                <p:nvPr/>
              </p:nvSpPr>
              <p:spPr>
                <a:xfrm>
                  <a:off x="10510204" y="8416072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1F7BC878-FEA6-9D2A-9D09-CCAE19818924}"/>
                    </a:ext>
                  </a:extLst>
                </p:cNvPr>
                <p:cNvSpPr txBox="1"/>
                <p:nvPr/>
              </p:nvSpPr>
              <p:spPr>
                <a:xfrm>
                  <a:off x="10150094" y="8491747"/>
                  <a:ext cx="38408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5DFDACC5-F29A-16C2-039C-F344FB3B8AAA}"/>
                    </a:ext>
                  </a:extLst>
                </p:cNvPr>
                <p:cNvSpPr txBox="1"/>
                <p:nvPr/>
              </p:nvSpPr>
              <p:spPr>
                <a:xfrm>
                  <a:off x="11020323" y="8416071"/>
                  <a:ext cx="275816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</p:grpSp>
          <p:grpSp>
            <p:nvGrpSpPr>
              <p:cNvPr id="111" name="Group 110">
                <a:extLst>
                  <a:ext uri="{FF2B5EF4-FFF2-40B4-BE49-F238E27FC236}">
                    <a16:creationId xmlns:a16="http://schemas.microsoft.com/office/drawing/2014/main" id="{6FD071F2-0675-1345-A6DD-BDC786C5AB92}"/>
                  </a:ext>
                </a:extLst>
              </p:cNvPr>
              <p:cNvGrpSpPr/>
              <p:nvPr/>
            </p:nvGrpSpPr>
            <p:grpSpPr>
              <a:xfrm>
                <a:off x="11433469" y="7602799"/>
                <a:ext cx="754691" cy="768700"/>
                <a:chOff x="11433469" y="7602799"/>
                <a:chExt cx="754691" cy="768700"/>
              </a:xfrm>
            </p:grpSpPr>
            <p:pic>
              <p:nvPicPr>
                <p:cNvPr id="112" name="Picture 111">
                  <a:extLst>
                    <a:ext uri="{FF2B5EF4-FFF2-40B4-BE49-F238E27FC236}">
                      <a16:creationId xmlns:a16="http://schemas.microsoft.com/office/drawing/2014/main" id="{DBEDC34F-F30A-C9CD-ACA0-97CC9533898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rcRect l="80909" t="26209" r="14547" b="23336"/>
                <a:stretch>
                  <a:fillRect/>
                </a:stretch>
              </p:blipFill>
              <p:spPr>
                <a:xfrm>
                  <a:off x="11548174" y="7755288"/>
                  <a:ext cx="127051" cy="616211"/>
                </a:xfrm>
                <a:prstGeom prst="rect">
                  <a:avLst/>
                </a:prstGeom>
              </p:spPr>
            </p:pic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B8539B22-2979-4DE9-438F-7E9E43AEAC5E}"/>
                    </a:ext>
                  </a:extLst>
                </p:cNvPr>
                <p:cNvSpPr txBox="1"/>
                <p:nvPr/>
              </p:nvSpPr>
              <p:spPr>
                <a:xfrm>
                  <a:off x="11593762" y="7805211"/>
                  <a:ext cx="437299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e-06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D80E11F7-FA63-B4FD-30B7-2DB5C4A9B956}"/>
                    </a:ext>
                  </a:extLst>
                </p:cNvPr>
                <p:cNvSpPr txBox="1"/>
                <p:nvPr/>
              </p:nvSpPr>
              <p:spPr>
                <a:xfrm>
                  <a:off x="11593761" y="7917756"/>
                  <a:ext cx="437299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e-06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CD3F741C-7FE6-D05A-C4E4-21355D42C451}"/>
                    </a:ext>
                  </a:extLst>
                </p:cNvPr>
                <p:cNvSpPr txBox="1"/>
                <p:nvPr/>
              </p:nvSpPr>
              <p:spPr>
                <a:xfrm>
                  <a:off x="11592166" y="8038994"/>
                  <a:ext cx="437299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e-06</a:t>
                  </a:r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A189C18D-8A7D-67EC-8478-7DE6CC7C3ECF}"/>
                    </a:ext>
                  </a:extLst>
                </p:cNvPr>
                <p:cNvSpPr txBox="1"/>
                <p:nvPr/>
              </p:nvSpPr>
              <p:spPr>
                <a:xfrm>
                  <a:off x="11433469" y="7602799"/>
                  <a:ext cx="754691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djusted </a:t>
                  </a:r>
                  <a:r>
                    <a:rPr lang="en-US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value</a:t>
                  </a:r>
                </a:p>
              </p:txBody>
            </p:sp>
          </p:grpSp>
        </p:grp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19CC0690-C9E3-BC44-5237-5A748B61D74D}"/>
                </a:ext>
              </a:extLst>
            </p:cNvPr>
            <p:cNvCxnSpPr>
              <a:cxnSpLocks/>
            </p:cNvCxnSpPr>
            <p:nvPr/>
          </p:nvCxnSpPr>
          <p:spPr>
            <a:xfrm>
              <a:off x="9590972" y="7596812"/>
              <a:ext cx="0" cy="8229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3" name="TextBox 142">
            <a:extLst>
              <a:ext uri="{FF2B5EF4-FFF2-40B4-BE49-F238E27FC236}">
                <a16:creationId xmlns:a16="http://schemas.microsoft.com/office/drawing/2014/main" id="{099CAC39-4105-A4C0-0625-B9631CEDA577}"/>
              </a:ext>
            </a:extLst>
          </p:cNvPr>
          <p:cNvSpPr txBox="1"/>
          <p:nvPr/>
        </p:nvSpPr>
        <p:spPr>
          <a:xfrm>
            <a:off x="1537557" y="6998968"/>
            <a:ext cx="5415962" cy="5688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S4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EGG pathway and GO analysis of overlapping DEGs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between LS-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C-WFPM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0.1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eated single follicles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3403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89</Words>
  <Application>Microsoft Office PowerPoint</Application>
  <PresentationFormat>Custom</PresentationFormat>
  <Paragraphs>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uhelika Mali</dc:creator>
  <cp:lastModifiedBy>Jiyang Zhang</cp:lastModifiedBy>
  <cp:revision>5</cp:revision>
  <dcterms:created xsi:type="dcterms:W3CDTF">2025-10-12T03:06:25Z</dcterms:created>
  <dcterms:modified xsi:type="dcterms:W3CDTF">2026-02-17T19:12:54Z</dcterms:modified>
</cp:coreProperties>
</file>